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0" r:id="rId2"/>
  </p:sldIdLst>
  <p:sldSz cx="6858000" cy="9144000" type="screen4x3"/>
  <p:notesSz cx="6797675" cy="9926638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33CC"/>
    <a:srgbClr val="820082"/>
    <a:srgbClr val="3333FF"/>
    <a:srgbClr val="00CCFF"/>
    <a:srgbClr val="990099"/>
    <a:srgbClr val="0000FF"/>
    <a:srgbClr val="00FFFF"/>
  </p:clrMru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836" autoAdjust="0"/>
  </p:normalViewPr>
  <p:slideViewPr>
    <p:cSldViewPr>
      <p:cViewPr>
        <p:scale>
          <a:sx n="100" d="100"/>
          <a:sy n="100" d="100"/>
        </p:scale>
        <p:origin x="-1014" y="-78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514350" y="2840570"/>
            <a:ext cx="5829300" cy="1960033"/>
          </a:xfrm>
        </p:spPr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Cliquez pour modifier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089317-DCC6-4844-A58F-6B41C4581D7D}" type="datetimeFigureOut">
              <a:rPr lang="fr-FR" smtClean="0"/>
              <a:pPr/>
              <a:t>08/02/201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D4DAB5-93E8-419A-A22A-9C40F6212691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089317-DCC6-4844-A58F-6B41C4581D7D}" type="datetimeFigureOut">
              <a:rPr lang="fr-FR" smtClean="0"/>
              <a:pPr/>
              <a:t>08/02/201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D4DAB5-93E8-419A-A22A-9C40F6212691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257177" y="488951"/>
            <a:ext cx="3357563" cy="10401300"/>
          </a:xfrm>
        </p:spPr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089317-DCC6-4844-A58F-6B41C4581D7D}" type="datetimeFigureOut">
              <a:rPr lang="fr-FR" smtClean="0"/>
              <a:pPr/>
              <a:t>08/02/201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D4DAB5-93E8-419A-A22A-9C40F6212691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089317-DCC6-4844-A58F-6B41C4581D7D}" type="datetimeFigureOut">
              <a:rPr lang="fr-FR" smtClean="0"/>
              <a:pPr/>
              <a:t>08/02/201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D4DAB5-93E8-419A-A22A-9C40F6212691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541735" y="3875621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089317-DCC6-4844-A58F-6B41C4581D7D}" type="datetimeFigureOut">
              <a:rPr lang="fr-FR" smtClean="0"/>
              <a:pPr/>
              <a:t>08/02/201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D4DAB5-93E8-419A-A22A-9C40F6212691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257177" y="2844801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2628902" y="2844801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089317-DCC6-4844-A58F-6B41C4581D7D}" type="datetimeFigureOut">
              <a:rPr lang="fr-FR" smtClean="0"/>
              <a:pPr/>
              <a:t>08/02/2016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D4DAB5-93E8-419A-A22A-9C40F6212691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2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42902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3483771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3483771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089317-DCC6-4844-A58F-6B41C4581D7D}" type="datetimeFigureOut">
              <a:rPr lang="fr-FR" smtClean="0"/>
              <a:pPr/>
              <a:t>08/02/2016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D4DAB5-93E8-419A-A22A-9C40F6212691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089317-DCC6-4844-A58F-6B41C4581D7D}" type="datetimeFigureOut">
              <a:rPr lang="fr-FR" smtClean="0"/>
              <a:pPr/>
              <a:t>08/02/2016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D4DAB5-93E8-419A-A22A-9C40F6212691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089317-DCC6-4844-A58F-6B41C4581D7D}" type="datetimeFigureOut">
              <a:rPr lang="fr-FR" smtClean="0"/>
              <a:pPr/>
              <a:t>08/02/2016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D4DAB5-93E8-419A-A22A-9C40F6212691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2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2681289" y="364070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342902" y="1913470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089317-DCC6-4844-A58F-6B41C4581D7D}" type="datetimeFigureOut">
              <a:rPr lang="fr-FR" smtClean="0"/>
              <a:pPr/>
              <a:t>08/02/2016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D4DAB5-93E8-419A-A22A-9C40F6212691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344216" y="6400801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344216" y="7156452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089317-DCC6-4844-A58F-6B41C4581D7D}" type="datetimeFigureOut">
              <a:rPr lang="fr-FR" smtClean="0"/>
              <a:pPr/>
              <a:t>08/02/2016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D4DAB5-93E8-419A-A22A-9C40F6212691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133604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342900" y="8475137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E089317-DCC6-4844-A58F-6B41C4581D7D}" type="datetimeFigureOut">
              <a:rPr lang="fr-FR" smtClean="0"/>
              <a:pPr/>
              <a:t>08/02/201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2343150" y="8475137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4914900" y="8475137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5D4DAB5-93E8-419A-A22A-9C40F6212691}" type="slidenum">
              <a:rPr lang="fr-FR" smtClean="0"/>
              <a:pPr/>
              <a:t>‹N°›</a:t>
            </a:fld>
            <a:endParaRPr lang="fr-FR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7" name="Tableau 6"/>
          <p:cNvGraphicFramePr>
            <a:graphicFrameLocks noGrp="1"/>
          </p:cNvGraphicFramePr>
          <p:nvPr/>
        </p:nvGraphicFramePr>
        <p:xfrm>
          <a:off x="92249" y="730472"/>
          <a:ext cx="6660001" cy="3202584"/>
        </p:xfrm>
        <a:graphic>
          <a:graphicData uri="http://schemas.openxmlformats.org/drawingml/2006/table">
            <a:tbl>
              <a:tblPr/>
              <a:tblGrid>
                <a:gridCol w="1613927"/>
                <a:gridCol w="360040"/>
                <a:gridCol w="288032"/>
                <a:gridCol w="1296144"/>
                <a:gridCol w="1368152"/>
                <a:gridCol w="432048"/>
                <a:gridCol w="792088"/>
                <a:gridCol w="509570"/>
              </a:tblGrid>
              <a:tr h="262890">
                <a:tc rowSpan="2"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 b="1" dirty="0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Variable</a:t>
                      </a:r>
                      <a:endParaRPr lang="fr-FR" sz="10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22256" marR="22256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 b="1" dirty="0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Number of fetuses</a:t>
                      </a:r>
                      <a:endParaRPr lang="fr-FR" sz="10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22256" marR="22256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000" b="1" dirty="0" err="1" smtClean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Median</a:t>
                      </a:r>
                      <a:r>
                        <a:rPr lang="fr-FR" sz="1000" b="1" dirty="0" smtClean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 [Q1; Q3]</a:t>
                      </a:r>
                      <a:endParaRPr lang="fr-FR" sz="1000" b="1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22256" marR="22256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endParaRPr lang="fr-FR" sz="10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22256" marR="22256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3"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 b="1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Fully adjusted linear model</a:t>
                      </a:r>
                      <a:endParaRPr lang="fr-FR" sz="10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22256" marR="22256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</a:tr>
              <a:tr h="223164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 b="1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C</a:t>
                      </a:r>
                      <a:endParaRPr lang="fr-FR" sz="10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22256" marR="22256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 b="1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E</a:t>
                      </a:r>
                      <a:endParaRPr lang="fr-FR" sz="10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22256" marR="22256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000" b="1" dirty="0" smtClean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C</a:t>
                      </a:r>
                      <a:endParaRPr lang="fr-FR" sz="1000" b="1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22256" marR="22256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000" b="1" dirty="0" smtClean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E</a:t>
                      </a:r>
                      <a:endParaRPr lang="fr-FR" sz="1000" b="1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22256" marR="22256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 b="1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β value</a:t>
                      </a:r>
                      <a:endParaRPr lang="fr-FR" sz="10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22256" marR="22256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 b="1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CI</a:t>
                      </a:r>
                      <a:endParaRPr lang="fr-FR" sz="10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22256" marR="22256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 b="1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p-value</a:t>
                      </a:r>
                      <a:endParaRPr lang="fr-FR" sz="10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22256" marR="22256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62895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Fetal </a:t>
                      </a:r>
                      <a:r>
                        <a:rPr lang="en-US" sz="1000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weight (g)</a:t>
                      </a:r>
                      <a:endParaRPr lang="fr-FR" sz="10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20816" marR="20816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21</a:t>
                      </a:r>
                      <a:endParaRPr lang="fr-FR" sz="10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22256" marR="22256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87</a:t>
                      </a:r>
                      <a:endParaRPr lang="fr-FR" sz="10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22256" marR="22256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000" dirty="0" smtClean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42.6 [39.4; 44.5]</a:t>
                      </a:r>
                      <a:endParaRPr lang="fr-FR" sz="10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20816" marR="20816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000" dirty="0" smtClean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38.8 [34.9; 41.8]</a:t>
                      </a:r>
                      <a:endParaRPr lang="fr-FR" sz="10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20816" marR="20816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-</a:t>
                      </a:r>
                      <a:r>
                        <a:rPr lang="en-US" sz="1000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0.485</a:t>
                      </a:r>
                      <a:endParaRPr lang="fr-FR" sz="10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22256" marR="22256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[-</a:t>
                      </a:r>
                      <a:r>
                        <a:rPr lang="en-US" sz="1000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4.036;3.066]</a:t>
                      </a:r>
                      <a:endParaRPr lang="fr-FR" sz="10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22256" marR="22256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0.793</a:t>
                      </a:r>
                      <a:endParaRPr lang="fr-FR" sz="10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22256" marR="22256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131445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Crown-rump </a:t>
                      </a:r>
                      <a:r>
                        <a:rPr lang="en-US" sz="1000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length (cm)</a:t>
                      </a:r>
                      <a:endParaRPr lang="fr-FR" sz="10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20816" marR="2081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21</a:t>
                      </a:r>
                      <a:endParaRPr lang="fr-FR" sz="10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22256" marR="2225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81</a:t>
                      </a:r>
                      <a:endParaRPr lang="fr-FR" sz="10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22256" marR="2225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000" dirty="0" smtClean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12.6 [12.3; 12.8]</a:t>
                      </a:r>
                      <a:endParaRPr lang="fr-FR" sz="10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20816" marR="2081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000" dirty="0" smtClean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12.2 [11.9; 12.4]</a:t>
                      </a:r>
                      <a:endParaRPr lang="fr-FR" sz="10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20816" marR="2081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-0.236</a:t>
                      </a:r>
                      <a:endParaRPr lang="fr-FR" sz="10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22256" marR="2225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[-0.521;0.05]</a:t>
                      </a:r>
                      <a:endParaRPr lang="fr-FR" sz="10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22256" marR="2225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0.136</a:t>
                      </a:r>
                      <a:endParaRPr lang="fr-FR" sz="10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22256" marR="2225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31445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Biparietal </a:t>
                      </a:r>
                      <a:r>
                        <a:rPr lang="en-US" sz="1000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diameter (mm)</a:t>
                      </a:r>
                      <a:endParaRPr lang="fr-FR" sz="10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20816" marR="2081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21</a:t>
                      </a:r>
                      <a:endParaRPr lang="fr-FR" sz="10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22256" marR="2225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87</a:t>
                      </a:r>
                      <a:endParaRPr lang="fr-FR" sz="10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22256" marR="2225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000" dirty="0" smtClean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16.6 [16.3; 16.8]</a:t>
                      </a:r>
                      <a:endParaRPr lang="fr-FR" sz="10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20816" marR="2081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000" dirty="0" smtClean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16.2 [15.7; 16.6]</a:t>
                      </a:r>
                      <a:endParaRPr lang="fr-FR" sz="10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20816" marR="2081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-</a:t>
                      </a:r>
                      <a:r>
                        <a:rPr lang="en-US" sz="1000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0.237</a:t>
                      </a:r>
                      <a:endParaRPr lang="fr-FR" sz="10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22256" marR="2225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[-</a:t>
                      </a:r>
                      <a:r>
                        <a:rPr lang="en-US" sz="1000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0.831;0.357</a:t>
                      </a:r>
                      <a:r>
                        <a:rPr lang="en-US" sz="1000" dirty="0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]</a:t>
                      </a:r>
                      <a:endParaRPr lang="fr-FR" sz="10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22256" marR="2225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0.448</a:t>
                      </a:r>
                      <a:endParaRPr lang="fr-FR" sz="10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22256" marR="2225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31445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Head </a:t>
                      </a:r>
                      <a:r>
                        <a:rPr lang="en-US" sz="1000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length (mm)</a:t>
                      </a:r>
                      <a:endParaRPr lang="fr-FR" sz="10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20816" marR="2081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21</a:t>
                      </a:r>
                      <a:endParaRPr lang="fr-FR" sz="10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22256" marR="2225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87</a:t>
                      </a:r>
                      <a:endParaRPr lang="fr-FR" sz="10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22256" marR="2225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000" dirty="0" smtClean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28.8 [28.0; 29.3]</a:t>
                      </a:r>
                      <a:endParaRPr lang="fr-FR" sz="10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20816" marR="2081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000" dirty="0" smtClean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27.8 [27.0; 28.5]</a:t>
                      </a:r>
                      <a:endParaRPr lang="fr-FR" sz="10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20816" marR="2081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-</a:t>
                      </a:r>
                      <a:r>
                        <a:rPr lang="en-US" sz="1000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0.143</a:t>
                      </a:r>
                      <a:endParaRPr lang="fr-FR" sz="10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22256" marR="2225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[-</a:t>
                      </a:r>
                      <a:r>
                        <a:rPr lang="en-US" sz="1000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0.772;0.487]</a:t>
                      </a:r>
                      <a:endParaRPr lang="fr-FR" sz="10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22256" marR="2225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0.665</a:t>
                      </a:r>
                      <a:endParaRPr lang="fr-FR" sz="10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22256" marR="2225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31445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Abdominal </a:t>
                      </a:r>
                      <a:r>
                        <a:rPr lang="en-US" sz="1000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perimeter (cm)</a:t>
                      </a:r>
                      <a:endParaRPr lang="fr-FR" sz="10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20816" marR="2081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21</a:t>
                      </a:r>
                      <a:endParaRPr lang="fr-FR" sz="10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22256" marR="2225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87</a:t>
                      </a:r>
                      <a:endParaRPr lang="fr-FR" sz="10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22256" marR="2225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000" dirty="0" smtClean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7.70 [7.50; 8.05]</a:t>
                      </a:r>
                      <a:endParaRPr lang="fr-FR" sz="10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20816" marR="2081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000" dirty="0" smtClean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7.50 [7.10; 7.80]</a:t>
                      </a:r>
                      <a:endParaRPr lang="fr-FR" sz="10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20816" marR="2081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-</a:t>
                      </a:r>
                      <a:r>
                        <a:rPr lang="en-US" sz="1000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0.148</a:t>
                      </a:r>
                      <a:endParaRPr lang="fr-FR" sz="10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22256" marR="2225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[-</a:t>
                      </a:r>
                      <a:r>
                        <a:rPr lang="en-US" sz="1000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0.555;0.259]</a:t>
                      </a:r>
                      <a:endParaRPr lang="fr-FR" sz="10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22256" marR="2225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0.489</a:t>
                      </a:r>
                      <a:endParaRPr lang="fr-FR" sz="10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22256" marR="2225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31445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Brain </a:t>
                      </a:r>
                      <a:r>
                        <a:rPr lang="en-US" sz="1000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weight (g)</a:t>
                      </a:r>
                      <a:endParaRPr lang="fr-FR" sz="10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20816" marR="20816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19</a:t>
                      </a:r>
                      <a:endParaRPr lang="fr-FR" sz="10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22256" marR="22256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79</a:t>
                      </a:r>
                      <a:endParaRPr lang="fr-FR" sz="10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22256" marR="22256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000" dirty="0" smtClean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1.05 [1.00; 1.09]</a:t>
                      </a:r>
                      <a:endParaRPr lang="fr-FR" sz="10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20816" marR="20816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000" dirty="0" smtClean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0.97 [0.92; 1.01]</a:t>
                      </a:r>
                      <a:endParaRPr lang="fr-FR" sz="10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20816" marR="20816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-</a:t>
                      </a:r>
                      <a:r>
                        <a:rPr lang="en-US" sz="1000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0.068</a:t>
                      </a:r>
                      <a:endParaRPr lang="fr-FR" sz="10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22256" marR="22256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[-</a:t>
                      </a:r>
                      <a:r>
                        <a:rPr lang="en-US" sz="1000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0.11;-0.026]</a:t>
                      </a:r>
                      <a:endParaRPr lang="fr-FR" sz="10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22256" marR="22256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0.01*</a:t>
                      </a:r>
                      <a:endParaRPr lang="fr-FR" sz="10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22256" marR="22256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162895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Brain/Fetus weight ratio</a:t>
                      </a:r>
                      <a:endParaRPr lang="fr-FR" sz="10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20816" marR="2081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19</a:t>
                      </a:r>
                      <a:endParaRPr lang="fr-FR" sz="10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22256" marR="2225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79</a:t>
                      </a:r>
                      <a:endParaRPr lang="fr-FR" sz="10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22256" marR="2225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000" dirty="0" smtClean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0.025 [0.024; 0.027]</a:t>
                      </a:r>
                      <a:endParaRPr lang="fr-FR" sz="10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20816" marR="2081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000" dirty="0" smtClean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0.025 [0.024; 0.028]</a:t>
                      </a:r>
                      <a:endParaRPr lang="fr-FR" sz="10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20816" marR="2081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-0.001</a:t>
                      </a:r>
                      <a:endParaRPr lang="fr-FR" sz="10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22256" marR="2225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[-0.004;0.001]</a:t>
                      </a:r>
                      <a:endParaRPr lang="fr-FR" sz="10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22256" marR="2225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0.382</a:t>
                      </a:r>
                      <a:endParaRPr lang="fr-FR" sz="10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22256" marR="2225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62895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Lung/Fetus weight ratio</a:t>
                      </a:r>
                      <a:endParaRPr lang="fr-FR" sz="10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20816" marR="2081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21</a:t>
                      </a:r>
                      <a:endParaRPr lang="fr-FR" sz="10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22256" marR="2225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86</a:t>
                      </a:r>
                      <a:endParaRPr lang="fr-FR" sz="10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22256" marR="2225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000" dirty="0" smtClean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0.030 [0.025; 0.032]</a:t>
                      </a:r>
                      <a:endParaRPr lang="fr-FR" sz="10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20816" marR="2081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000" dirty="0" smtClean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0.028 [0.026; 0.031]</a:t>
                      </a:r>
                      <a:endParaRPr lang="fr-FR" sz="10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20816" marR="2081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-0.001</a:t>
                      </a:r>
                      <a:endParaRPr lang="fr-FR" sz="10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22256" marR="2225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[-</a:t>
                      </a:r>
                      <a:r>
                        <a:rPr lang="en-US" sz="1000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0.004;0.002]</a:t>
                      </a:r>
                      <a:endParaRPr lang="fr-FR" sz="10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22256" marR="2225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0.551</a:t>
                      </a:r>
                      <a:endParaRPr lang="fr-FR" sz="10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22256" marR="2225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31445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Heart/Fetus weight ratio</a:t>
                      </a:r>
                      <a:endParaRPr lang="fr-FR" sz="10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20816" marR="2081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21</a:t>
                      </a:r>
                      <a:endParaRPr lang="fr-FR" sz="10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22256" marR="2225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85</a:t>
                      </a:r>
                      <a:endParaRPr lang="fr-FR" sz="10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22256" marR="2225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000" dirty="0" smtClean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0.0050 [0.0048; 0.0056]</a:t>
                      </a:r>
                      <a:endParaRPr lang="fr-FR" sz="10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20816" marR="2081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000" dirty="0" smtClean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0.0051 [0.0047; 0.0057]</a:t>
                      </a:r>
                      <a:endParaRPr lang="fr-FR" sz="10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20816" marR="2081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0</a:t>
                      </a:r>
                      <a:endParaRPr lang="fr-FR" sz="10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22256" marR="2225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[0;0]</a:t>
                      </a:r>
                      <a:endParaRPr lang="fr-FR" sz="10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22256" marR="2225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0.589</a:t>
                      </a:r>
                      <a:endParaRPr lang="fr-FR" sz="10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22256" marR="2225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62895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Liver/Fetus weight ratio</a:t>
                      </a:r>
                      <a:endParaRPr lang="fr-FR" sz="10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20816" marR="2081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21</a:t>
                      </a:r>
                      <a:endParaRPr lang="fr-FR" sz="10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22256" marR="2225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86</a:t>
                      </a:r>
                      <a:endParaRPr lang="fr-FR" sz="10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22256" marR="2225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000" dirty="0" smtClean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0.071 [0.068; 0.076]</a:t>
                      </a:r>
                      <a:endParaRPr lang="fr-FR" sz="10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20816" marR="2081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000" dirty="0" smtClean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0.072 [0.067; 0.077]</a:t>
                      </a:r>
                      <a:endParaRPr lang="fr-FR" sz="10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20816" marR="2081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0.001</a:t>
                      </a:r>
                      <a:endParaRPr lang="fr-FR" sz="10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22256" marR="2225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[-</a:t>
                      </a:r>
                      <a:r>
                        <a:rPr lang="en-US" sz="1000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0.004;0.006]</a:t>
                      </a:r>
                      <a:endParaRPr lang="fr-FR" sz="10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22256" marR="2225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0.835</a:t>
                      </a:r>
                      <a:endParaRPr lang="fr-FR" sz="10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22256" marR="2225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31445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Kidney/Fetus weight ratio</a:t>
                      </a:r>
                      <a:endParaRPr lang="fr-FR" sz="10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20816" marR="2081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21</a:t>
                      </a:r>
                      <a:endParaRPr lang="fr-FR" sz="10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22256" marR="2225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86</a:t>
                      </a:r>
                      <a:endParaRPr lang="fr-FR" sz="10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22256" marR="2225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000" dirty="0" smtClean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0.0092 [0.0088; 0.0100]</a:t>
                      </a:r>
                      <a:endParaRPr lang="fr-FR" sz="10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20816" marR="2081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000" dirty="0" smtClean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0.0087 [0.0082; 0.0093]</a:t>
                      </a:r>
                      <a:endParaRPr lang="fr-FR" sz="10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20816" marR="2081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-0.001</a:t>
                      </a:r>
                      <a:endParaRPr lang="fr-FR" sz="10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22256" marR="2225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[-0.001;0]</a:t>
                      </a:r>
                      <a:endParaRPr lang="fr-FR" sz="10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22256" marR="2225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0.213</a:t>
                      </a:r>
                      <a:endParaRPr lang="fr-FR" sz="10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22256" marR="2225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62895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Placental </a:t>
                      </a:r>
                      <a:r>
                        <a:rPr lang="en-US" sz="1000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weight (g)</a:t>
                      </a:r>
                      <a:endParaRPr lang="fr-FR" sz="10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20816" marR="20816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21</a:t>
                      </a:r>
                      <a:endParaRPr lang="fr-FR" sz="10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22256" marR="22256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87</a:t>
                      </a:r>
                      <a:endParaRPr lang="fr-FR" sz="10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22256" marR="22256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000" dirty="0" smtClean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7.5 [6.51; 9.12]</a:t>
                      </a:r>
                      <a:endParaRPr lang="fr-FR" sz="10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20816" marR="20816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000" dirty="0" smtClean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6.76 [5.62; 7.68]</a:t>
                      </a:r>
                      <a:endParaRPr lang="fr-FR" sz="10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20816" marR="20816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0.047</a:t>
                      </a:r>
                      <a:endParaRPr lang="fr-FR" sz="10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22256" marR="22256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[-</a:t>
                      </a:r>
                      <a:r>
                        <a:rPr lang="en-US" sz="1000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1.467;1.561]</a:t>
                      </a:r>
                      <a:endParaRPr lang="fr-FR" sz="10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22256" marR="22256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0.952</a:t>
                      </a:r>
                      <a:endParaRPr lang="fr-FR" sz="10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22256" marR="22256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131445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Labyrinthine area </a:t>
                      </a:r>
                      <a:r>
                        <a:rPr lang="en-US" sz="1000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weight (g)</a:t>
                      </a:r>
                      <a:endParaRPr lang="fr-FR" sz="10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20816" marR="2081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21</a:t>
                      </a:r>
                      <a:endParaRPr lang="fr-FR" sz="10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22256" marR="2225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87</a:t>
                      </a:r>
                      <a:endParaRPr lang="fr-FR" sz="10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22256" marR="2225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000" dirty="0" smtClean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5.36 [4.31; 6.25]</a:t>
                      </a:r>
                      <a:endParaRPr lang="fr-FR" sz="10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20816" marR="2081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000" dirty="0" smtClean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4.33 [3.84; 5.12]</a:t>
                      </a:r>
                      <a:endParaRPr lang="fr-FR" sz="10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20816" marR="2081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-0.356</a:t>
                      </a:r>
                      <a:endParaRPr lang="fr-FR" sz="10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22256" marR="2225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[-1.53;0.819]</a:t>
                      </a:r>
                      <a:endParaRPr lang="fr-FR" sz="10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22256" marR="2225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0.563</a:t>
                      </a:r>
                      <a:endParaRPr lang="fr-FR" sz="10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22256" marR="2225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62895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Decidual </a:t>
                      </a:r>
                      <a:r>
                        <a:rPr lang="en-US" sz="1000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weight (g)</a:t>
                      </a:r>
                      <a:endParaRPr lang="fr-FR" sz="10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20816" marR="2081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21</a:t>
                      </a:r>
                      <a:endParaRPr lang="fr-FR" sz="10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22256" marR="2225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87</a:t>
                      </a:r>
                      <a:endParaRPr lang="fr-FR" sz="10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22256" marR="2225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000" dirty="0" smtClean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2.31 [1.94; 2.86]</a:t>
                      </a:r>
                      <a:endParaRPr lang="fr-FR" sz="10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20816" marR="2081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000" dirty="0" smtClean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2.23 [1.78; 2.77]</a:t>
                      </a:r>
                      <a:endParaRPr lang="fr-FR" sz="10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20816" marR="2081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0.384</a:t>
                      </a:r>
                      <a:endParaRPr lang="fr-FR" sz="10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22256" marR="2225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[-0.267;1.035]</a:t>
                      </a:r>
                      <a:endParaRPr lang="fr-FR" sz="10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22256" marR="2225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0.273</a:t>
                      </a:r>
                      <a:endParaRPr lang="fr-FR" sz="10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22256" marR="2225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31445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Placental efficiency</a:t>
                      </a:r>
                      <a:endParaRPr lang="fr-FR" sz="10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20816" marR="2081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21</a:t>
                      </a:r>
                      <a:endParaRPr lang="fr-FR" sz="10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22256" marR="2225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87</a:t>
                      </a:r>
                      <a:endParaRPr lang="fr-FR" sz="10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22256" marR="2225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000" dirty="0" smtClean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5.38 [4.83; 6.18]</a:t>
                      </a:r>
                      <a:endParaRPr lang="fr-FR" sz="10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20816" marR="2081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000" dirty="0" smtClean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5.64 [5.24; 6.23]</a:t>
                      </a:r>
                      <a:endParaRPr lang="fr-FR" sz="10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20816" marR="2081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-0.212</a:t>
                      </a:r>
                      <a:endParaRPr lang="fr-FR" sz="10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22256" marR="2225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[-</a:t>
                      </a:r>
                      <a:r>
                        <a:rPr lang="en-US" sz="1000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1.051;0.627]</a:t>
                      </a:r>
                      <a:endParaRPr lang="fr-FR" sz="10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22256" marR="2225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0.629</a:t>
                      </a:r>
                      <a:endParaRPr lang="fr-FR" sz="10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22256" marR="2225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  <p:sp>
        <p:nvSpPr>
          <p:cNvPr id="8" name="ZoneTexte 7"/>
          <p:cNvSpPr txBox="1"/>
          <p:nvPr/>
        </p:nvSpPr>
        <p:spPr>
          <a:xfrm>
            <a:off x="92249" y="452273"/>
            <a:ext cx="66600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fr-FR" sz="1200" b="1" dirty="0" smtClean="0">
                <a:latin typeface="Times New Roman" pitchFamily="18" charset="0"/>
                <a:cs typeface="Times New Roman" pitchFamily="18" charset="0"/>
              </a:rPr>
              <a:t>Table </a:t>
            </a:r>
            <a:r>
              <a:rPr lang="fr-FR" sz="1200" b="1" dirty="0" smtClean="0">
                <a:latin typeface="Times New Roman" pitchFamily="18" charset="0"/>
                <a:cs typeface="Times New Roman" pitchFamily="18" charset="0"/>
              </a:rPr>
              <a:t>S8 </a:t>
            </a:r>
            <a:r>
              <a:rPr lang="fr-FR" sz="1200" b="1" dirty="0" smtClean="0">
                <a:latin typeface="Times New Roman" pitchFamily="18" charset="0"/>
                <a:cs typeface="Times New Roman" pitchFamily="18" charset="0"/>
              </a:rPr>
              <a:t>| </a:t>
            </a:r>
            <a:r>
              <a:rPr lang="en-US" sz="1200" b="1" dirty="0" smtClean="0">
                <a:latin typeface="Times New Roman" pitchFamily="18" charset="0"/>
                <a:cs typeface="Times New Roman" pitchFamily="18" charset="0"/>
              </a:rPr>
              <a:t>Fetoplacental biometry at 28 </a:t>
            </a:r>
            <a:r>
              <a:rPr lang="en-US" sz="1200" b="1" dirty="0" err="1" smtClean="0">
                <a:latin typeface="Times New Roman" pitchFamily="18" charset="0"/>
                <a:cs typeface="Times New Roman" pitchFamily="18" charset="0"/>
              </a:rPr>
              <a:t>dpc</a:t>
            </a:r>
            <a:r>
              <a:rPr lang="en-US" sz="1200" b="1" dirty="0" smtClean="0">
                <a:latin typeface="Times New Roman" pitchFamily="18" charset="0"/>
                <a:cs typeface="Times New Roman" pitchFamily="18" charset="0"/>
              </a:rPr>
              <a:t> for the second generation. </a:t>
            </a:r>
            <a:endParaRPr lang="fr-FR" sz="12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9" name="ZoneTexte 8"/>
          <p:cNvSpPr txBox="1"/>
          <p:nvPr/>
        </p:nvSpPr>
        <p:spPr>
          <a:xfrm>
            <a:off x="92249" y="3933056"/>
            <a:ext cx="6660000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Female rabbits inhaled 1mg/m</a:t>
            </a:r>
            <a:r>
              <a:rPr lang="en-US" sz="1200" baseline="30000" dirty="0" smtClean="0">
                <a:latin typeface="Times New Roman" pitchFamily="18" charset="0"/>
                <a:cs typeface="Times New Roman" pitchFamily="18" charset="0"/>
              </a:rPr>
              <a:t>3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of NPs, 2 hours/day, 5 days/week, from 3 </a:t>
            </a:r>
            <a:r>
              <a:rPr lang="en-US" sz="1200" dirty="0" err="1" smtClean="0">
                <a:latin typeface="Times New Roman" pitchFamily="18" charset="0"/>
                <a:cs typeface="Times New Roman" pitchFamily="18" charset="0"/>
              </a:rPr>
              <a:t>dpc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 to 27dpc. Dams were allowed to give birth generation F1. Adult F1 female (7.5 months of age) were mated and euthanized pregnant at 28 </a:t>
            </a:r>
            <a:r>
              <a:rPr lang="en-US" sz="1200" dirty="0" err="1" smtClean="0">
                <a:latin typeface="Times New Roman" pitchFamily="18" charset="0"/>
                <a:cs typeface="Times New Roman" pitchFamily="18" charset="0"/>
              </a:rPr>
              <a:t>dpc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. Fetoplacental units of generation F2 were collected in control (C) and exposed (E) groups. Effect of grand-dam (F0) pregnancy exposure to engine diesel exhaust on second-generation fetuses was estimated using linear model with random effect of dam (F1) adjusted for number of fetuses by dam, fetus position in the horn and fetus sex. </a:t>
            </a:r>
            <a:r>
              <a:rPr lang="fr-FR" sz="1200" dirty="0" smtClean="0">
                <a:latin typeface="Times New Roman" pitchFamily="18" charset="0"/>
                <a:cs typeface="Times New Roman" pitchFamily="18" charset="0"/>
              </a:rPr>
              <a:t>All data are </a:t>
            </a:r>
            <a:r>
              <a:rPr lang="fr-FR" sz="1200" dirty="0" err="1" smtClean="0">
                <a:latin typeface="Times New Roman" pitchFamily="18" charset="0"/>
                <a:cs typeface="Times New Roman" pitchFamily="18" charset="0"/>
              </a:rPr>
              <a:t>expressed</a:t>
            </a:r>
            <a:r>
              <a:rPr lang="fr-FR" sz="1200" dirty="0" smtClean="0">
                <a:latin typeface="Times New Roman" pitchFamily="18" charset="0"/>
                <a:cs typeface="Times New Roman" pitchFamily="18" charset="0"/>
              </a:rPr>
              <a:t> as </a:t>
            </a:r>
            <a:r>
              <a:rPr lang="fr-FR" sz="1200" dirty="0" err="1" smtClean="0">
                <a:latin typeface="Times New Roman" pitchFamily="18" charset="0"/>
                <a:cs typeface="Times New Roman" pitchFamily="18" charset="0"/>
              </a:rPr>
              <a:t>median</a:t>
            </a:r>
            <a:r>
              <a:rPr lang="fr-FR" sz="1200" dirty="0" smtClean="0">
                <a:latin typeface="Times New Roman" pitchFamily="18" charset="0"/>
                <a:cs typeface="Times New Roman" pitchFamily="18" charset="0"/>
              </a:rPr>
              <a:t>[Q1;Q3].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(*p &lt; 0.05).</a:t>
            </a:r>
            <a:endParaRPr lang="fr-FR" sz="1200" dirty="0" smtClean="0">
              <a:latin typeface="Times New Roman" pitchFamily="18" charset="0"/>
              <a:cs typeface="Times New Roman" pitchFamily="18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509</TotalTime>
  <Words>519</Words>
  <Application>Microsoft Office PowerPoint</Application>
  <PresentationFormat>Affichage à l'écran (4:3)</PresentationFormat>
  <Paragraphs>133</Paragraphs>
  <Slides>1</Slides>
  <Notes>0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2" baseType="lpstr">
      <vt:lpstr>Thème Office</vt:lpstr>
      <vt:lpstr>Diapositive 1</vt:lpstr>
    </vt:vector>
  </TitlesOfParts>
  <Company>INRA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e 1</dc:title>
  <dc:creator>svalentino</dc:creator>
  <cp:lastModifiedBy>Sarah</cp:lastModifiedBy>
  <cp:revision>62</cp:revision>
  <dcterms:created xsi:type="dcterms:W3CDTF">2015-02-24T15:36:47Z</dcterms:created>
  <dcterms:modified xsi:type="dcterms:W3CDTF">2016-02-08T10:31:14Z</dcterms:modified>
</cp:coreProperties>
</file>